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2" r:id="rId3"/>
    <p:sldId id="265" r:id="rId4"/>
    <p:sldId id="263" r:id="rId5"/>
    <p:sldId id="264" r:id="rId6"/>
    <p:sldId id="268" r:id="rId7"/>
    <p:sldId id="269" r:id="rId8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4559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-360" y="-9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181" indent="0" algn="ctr">
              <a:buNone/>
              <a:defRPr sz="2000"/>
            </a:lvl2pPr>
            <a:lvl3pPr marL="914362" indent="0" algn="ctr">
              <a:buNone/>
              <a:defRPr sz="1800"/>
            </a:lvl3pPr>
            <a:lvl4pPr marL="1371543" indent="0" algn="ctr">
              <a:buNone/>
              <a:defRPr sz="1600"/>
            </a:lvl4pPr>
            <a:lvl5pPr marL="1828723" indent="0" algn="ctr">
              <a:buNone/>
              <a:defRPr sz="1600"/>
            </a:lvl5pPr>
            <a:lvl6pPr marL="2285905" indent="0" algn="ctr">
              <a:buNone/>
              <a:defRPr sz="1600"/>
            </a:lvl6pPr>
            <a:lvl7pPr marL="2743085" indent="0" algn="ctr">
              <a:buNone/>
              <a:defRPr sz="1600"/>
            </a:lvl7pPr>
            <a:lvl8pPr marL="3200266" indent="0" algn="ctr">
              <a:buNone/>
              <a:defRPr sz="1600"/>
            </a:lvl8pPr>
            <a:lvl9pPr marL="3657446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B392B-DACE-4E26-A11D-B28BE2FEF534}" type="datetimeFigureOut">
              <a:rPr lang="en-GB" smtClean="0"/>
              <a:t>24/11/201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30B09-AF3D-47BA-9E65-54E050043010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21885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B392B-DACE-4E26-A11D-B28BE2FEF534}" type="datetimeFigureOut">
              <a:rPr lang="en-GB" smtClean="0"/>
              <a:t>24/11/201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30B09-AF3D-47BA-9E65-54E050043010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14318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B392B-DACE-4E26-A11D-B28BE2FEF534}" type="datetimeFigureOut">
              <a:rPr lang="en-GB" smtClean="0"/>
              <a:t>24/11/201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30B09-AF3D-47BA-9E65-54E050043010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7917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B392B-DACE-4E26-A11D-B28BE2FEF534}" type="datetimeFigureOut">
              <a:rPr lang="en-GB" smtClean="0"/>
              <a:t>24/11/201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30B09-AF3D-47BA-9E65-54E050043010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404283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1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1" y="4589466"/>
            <a:ext cx="8543925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/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B392B-DACE-4E26-A11D-B28BE2FEF534}" type="datetimeFigureOut">
              <a:rPr lang="en-GB" smtClean="0"/>
              <a:t>24/11/201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30B09-AF3D-47BA-9E65-54E050043010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528300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B392B-DACE-4E26-A11D-B28BE2FEF534}" type="datetimeFigureOut">
              <a:rPr lang="en-GB" smtClean="0"/>
              <a:t>24/11/201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30B09-AF3D-47BA-9E65-54E050043010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30849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4"/>
            <a:ext cx="4190702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6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B392B-DACE-4E26-A11D-B28BE2FEF534}" type="datetimeFigureOut">
              <a:rPr lang="en-GB" smtClean="0"/>
              <a:t>24/11/201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30B09-AF3D-47BA-9E65-54E050043010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49965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B392B-DACE-4E26-A11D-B28BE2FEF534}" type="datetimeFigureOut">
              <a:rPr lang="en-GB" smtClean="0"/>
              <a:t>24/11/201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30B09-AF3D-47BA-9E65-54E050043010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36643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B392B-DACE-4E26-A11D-B28BE2FEF534}" type="datetimeFigureOut">
              <a:rPr lang="en-GB" smtClean="0"/>
              <a:t>24/11/201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30B09-AF3D-47BA-9E65-54E050043010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81276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8"/>
            <a:ext cx="5014913" cy="4873625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B392B-DACE-4E26-A11D-B28BE2FEF534}" type="datetimeFigureOut">
              <a:rPr lang="en-GB" smtClean="0"/>
              <a:t>24/11/201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30B09-AF3D-47BA-9E65-54E050043010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75881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8"/>
            <a:ext cx="5014913" cy="4873625"/>
          </a:xfrm>
        </p:spPr>
        <p:txBody>
          <a:bodyPr anchor="t"/>
          <a:lstStyle>
            <a:lvl1pPr marL="0" indent="0">
              <a:buNone/>
              <a:defRPr sz="3199"/>
            </a:lvl1pPr>
            <a:lvl2pPr marL="457181" indent="0">
              <a:buNone/>
              <a:defRPr sz="2799"/>
            </a:lvl2pPr>
            <a:lvl3pPr marL="914362" indent="0">
              <a:buNone/>
              <a:defRPr sz="2401"/>
            </a:lvl3pPr>
            <a:lvl4pPr marL="1371543" indent="0">
              <a:buNone/>
              <a:defRPr sz="2000"/>
            </a:lvl4pPr>
            <a:lvl5pPr marL="1828723" indent="0">
              <a:buNone/>
              <a:defRPr sz="2000"/>
            </a:lvl5pPr>
            <a:lvl6pPr marL="2285905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6" indent="0">
              <a:buNone/>
              <a:defRPr sz="2000"/>
            </a:lvl9pPr>
          </a:lstStyle>
          <a:p>
            <a:r>
              <a:rPr lang="en-US" dirty="0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B392B-DACE-4E26-A11D-B28BE2FEF534}" type="datetimeFigureOut">
              <a:rPr lang="en-GB" smtClean="0"/>
              <a:t>24/11/201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30B09-AF3D-47BA-9E65-54E050043010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40462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4B392B-DACE-4E26-A11D-B28BE2FEF534}" type="datetimeFigureOut">
              <a:rPr lang="en-GB" smtClean="0"/>
              <a:t>24/11/201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130B09-AF3D-47BA-9E65-54E050043010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83469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6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2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71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2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6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8334210"/>
              </p:ext>
            </p:extLst>
          </p:nvPr>
        </p:nvGraphicFramePr>
        <p:xfrm>
          <a:off x="1226158" y="3133453"/>
          <a:ext cx="7353480" cy="1112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36368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stKeeper vs.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RT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B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WHAZ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H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I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L4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s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eff. of corr. [r]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95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8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17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9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40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67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03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67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19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8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132899" y="615104"/>
            <a:ext cx="17186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Unloaded </a:t>
            </a:r>
            <a:endParaRPr lang="en-GB" sz="1200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7478405"/>
              </p:ext>
            </p:extLst>
          </p:nvPr>
        </p:nvGraphicFramePr>
        <p:xfrm>
          <a:off x="1226157" y="1018215"/>
          <a:ext cx="7353480" cy="1112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36368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stKeeper vs.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RT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B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WHAZ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H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I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L4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s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eff. of corr. [r]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73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82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2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72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0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08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77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14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81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09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16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132899" y="2620177"/>
            <a:ext cx="17186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Loaded (8MPa)</a:t>
            </a:r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8189843" y="6569167"/>
            <a:ext cx="16697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l Table 1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38496838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7859011"/>
              </p:ext>
            </p:extLst>
          </p:nvPr>
        </p:nvGraphicFramePr>
        <p:xfrm>
          <a:off x="1226158" y="3133453"/>
          <a:ext cx="7353480" cy="1112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36368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stKeeper vs.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RT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B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WHAZ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H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I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L4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s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eff. of corr. [r]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56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24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70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63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55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27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99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0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0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132899" y="615104"/>
            <a:ext cx="17186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Unloaded </a:t>
            </a:r>
            <a:endParaRPr lang="en-GB" sz="12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3156304"/>
              </p:ext>
            </p:extLst>
          </p:nvPr>
        </p:nvGraphicFramePr>
        <p:xfrm>
          <a:off x="1226157" y="1018215"/>
          <a:ext cx="7353480" cy="1112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36368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stKeeper vs.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RT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B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WHAZ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H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I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L4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s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eff. of corr. [r]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87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8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5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82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36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43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66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73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9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3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132899" y="2642211"/>
            <a:ext cx="32187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Loaded (5MPa, 4Hz, 24hrs post-load extraction)</a:t>
            </a:r>
            <a:endParaRPr lang="en-GB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8189843" y="6569167"/>
            <a:ext cx="16697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l Table 2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3168998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4899276"/>
              </p:ext>
            </p:extLst>
          </p:nvPr>
        </p:nvGraphicFramePr>
        <p:xfrm>
          <a:off x="1226158" y="3133453"/>
          <a:ext cx="7353480" cy="1112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36368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stKeeper vs.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RT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B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WHAZ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H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I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L4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s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eff. of corr. [r]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40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38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09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08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97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05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06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67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40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73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1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16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03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3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75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132899" y="615104"/>
            <a:ext cx="17186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Unloaded </a:t>
            </a:r>
            <a:endParaRPr lang="en-GB" sz="12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5060605"/>
              </p:ext>
            </p:extLst>
          </p:nvPr>
        </p:nvGraphicFramePr>
        <p:xfrm>
          <a:off x="1226157" y="1018215"/>
          <a:ext cx="7353480" cy="1112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36368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stKeeper vs.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RT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B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WHAZ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H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I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L4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s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eff. of corr. [r]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70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85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92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63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69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84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69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47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78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39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65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132898" y="2642211"/>
            <a:ext cx="3509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Loaded (2.5MPa, 1Hz, 24hrs post-load extraction)</a:t>
            </a:r>
            <a:endParaRPr lang="en-GB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8189843" y="6569167"/>
            <a:ext cx="16697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l Table 3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37468401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3324782"/>
              </p:ext>
            </p:extLst>
          </p:nvPr>
        </p:nvGraphicFramePr>
        <p:xfrm>
          <a:off x="1226158" y="3133453"/>
          <a:ext cx="7353480" cy="1112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36368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stKeeper vs.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RT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B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WHAZ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H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I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L4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s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eff. of corr. [r]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43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21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05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22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3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20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81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92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55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81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86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67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65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48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132899" y="615104"/>
            <a:ext cx="17186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Unloaded </a:t>
            </a:r>
            <a:endParaRPr lang="en-GB" sz="12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4376201"/>
              </p:ext>
            </p:extLst>
          </p:nvPr>
        </p:nvGraphicFramePr>
        <p:xfrm>
          <a:off x="1226157" y="1018215"/>
          <a:ext cx="7353480" cy="1112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36368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stKeeper vs.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RT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B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WHAZ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H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I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L4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s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eff. of corr. [r]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80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96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49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08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02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57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79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48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67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37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63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2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06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9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29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26</a:t>
                      </a:r>
                      <a:endParaRPr lang="en-GB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132899" y="2642211"/>
            <a:ext cx="32187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Loaded (5MPa, 4Hz, direct extraction)</a:t>
            </a:r>
            <a:endParaRPr lang="en-GB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8189843" y="6569167"/>
            <a:ext cx="16697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l Table 4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1185544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4824663"/>
              </p:ext>
            </p:extLst>
          </p:nvPr>
        </p:nvGraphicFramePr>
        <p:xfrm>
          <a:off x="1226158" y="3133453"/>
          <a:ext cx="7353480" cy="1112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36368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stKeeper vs.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RT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B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WHAZ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H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I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L4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s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eff. of corr. [r]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000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8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3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3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27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0" dirty="0" smtClean="0"/>
                        <a:t>0.008</a:t>
                      </a:r>
                      <a:endParaRPr lang="en-GB" sz="1200" b="0" dirty="0"/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62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73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4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0" dirty="0" smtClean="0"/>
                        <a:t>0.001</a:t>
                      </a:r>
                      <a:endParaRPr lang="en-GB" sz="1200" b="0" dirty="0"/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132899" y="615104"/>
            <a:ext cx="17186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Unloaded </a:t>
            </a:r>
            <a:endParaRPr lang="en-GB" sz="12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111321"/>
              </p:ext>
            </p:extLst>
          </p:nvPr>
        </p:nvGraphicFramePr>
        <p:xfrm>
          <a:off x="1226157" y="1018215"/>
          <a:ext cx="7353480" cy="1112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36368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  <a:gridCol w="764639"/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stKeeper vs.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RT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B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WHAZ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H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IA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L4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s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smtClea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eff. of corr. [r]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5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54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5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0" dirty="0" smtClean="0"/>
                        <a:t>0.975</a:t>
                      </a:r>
                      <a:endParaRPr lang="en-GB" sz="1200" b="0" dirty="0"/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06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33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57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66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41</a:t>
                      </a:r>
                      <a:endParaRPr lang="en-GB" sz="11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0" dirty="0" smtClean="0"/>
                        <a:t>0.005</a:t>
                      </a:r>
                      <a:endParaRPr lang="en-GB" sz="1200" b="0" dirty="0"/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79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  <a:endParaRPr lang="en-GB" sz="11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R w="12700" cmpd="sng">
                      <a:noFill/>
                    </a:lnR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132899" y="2642211"/>
            <a:ext cx="32187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Loaded (7.5% elongation, 1Hz)</a:t>
            </a:r>
            <a:endParaRPr lang="en-GB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8189843" y="6569167"/>
            <a:ext cx="16697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l Table 5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5330165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62888" y="696805"/>
            <a:ext cx="3297209" cy="202021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98504" y="696805"/>
            <a:ext cx="3297209" cy="202021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7410" y="535717"/>
            <a:ext cx="412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A.</a:t>
            </a:r>
            <a:endParaRPr lang="en-GB" sz="12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338016" y="533569"/>
            <a:ext cx="412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B.</a:t>
            </a:r>
            <a:endParaRPr lang="en-GB" sz="12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583497" y="533569"/>
            <a:ext cx="412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C.</a:t>
            </a:r>
            <a:endParaRPr lang="en-GB" sz="1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8007905" y="6581001"/>
            <a:ext cx="18803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l Figure 1</a:t>
            </a:r>
            <a:endParaRPr lang="en-GB" sz="1200" b="1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08366" y="696801"/>
            <a:ext cx="3297209" cy="2020217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197248" y="1223492"/>
            <a:ext cx="7648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p=0.015</a:t>
            </a:r>
            <a:endParaRPr lang="en-GB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5553464" y="1355654"/>
            <a:ext cx="7648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p=0.009</a:t>
            </a:r>
            <a:endParaRPr lang="en-GB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8797099" y="1214190"/>
            <a:ext cx="7648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p=0.038</a:t>
            </a:r>
            <a:endParaRPr lang="en-GB" sz="1200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39151" y="3658940"/>
            <a:ext cx="3297209" cy="2020217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88653" y="3658942"/>
            <a:ext cx="3297209" cy="2020217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310706" y="3381941"/>
            <a:ext cx="412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D.</a:t>
            </a:r>
            <a:endParaRPr lang="en-GB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5065927" y="3381941"/>
            <a:ext cx="412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E.</a:t>
            </a:r>
            <a:endParaRPr lang="en-GB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3544078" y="3938787"/>
            <a:ext cx="7648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p=0.570</a:t>
            </a:r>
            <a:endParaRPr lang="en-GB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7243011" y="4510714"/>
            <a:ext cx="7648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p=0.010</a:t>
            </a:r>
            <a:endParaRPr lang="en-GB" sz="1200" dirty="0"/>
          </a:p>
        </p:txBody>
      </p:sp>
      <p:grpSp>
        <p:nvGrpSpPr>
          <p:cNvPr id="18" name="Group 17"/>
          <p:cNvGrpSpPr/>
          <p:nvPr/>
        </p:nvGrpSpPr>
        <p:grpSpPr>
          <a:xfrm>
            <a:off x="2619357" y="2930326"/>
            <a:ext cx="4108804" cy="253595"/>
            <a:chOff x="3107765" y="5489980"/>
            <a:chExt cx="4108804" cy="253595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7"/>
            <a:srcRect l="72421" t="7546" b="85563"/>
            <a:stretch/>
          </p:blipFill>
          <p:spPr>
            <a:xfrm>
              <a:off x="3400424" y="5489980"/>
              <a:ext cx="1436609" cy="215495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7"/>
            <a:srcRect l="72453" t="14398" b="78421"/>
            <a:stretch/>
          </p:blipFill>
          <p:spPr>
            <a:xfrm>
              <a:off x="5781674" y="5519047"/>
              <a:ext cx="1434895" cy="224528"/>
            </a:xfrm>
            <a:prstGeom prst="rect">
              <a:avLst/>
            </a:prstGeom>
          </p:spPr>
        </p:pic>
        <p:sp>
          <p:nvSpPr>
            <p:cNvPr id="21" name="Oval 20"/>
            <p:cNvSpPr/>
            <p:nvPr/>
          </p:nvSpPr>
          <p:spPr>
            <a:xfrm>
              <a:off x="3107765" y="5545196"/>
              <a:ext cx="131482" cy="128791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Oval 21"/>
            <p:cNvSpPr/>
            <p:nvPr/>
          </p:nvSpPr>
          <p:spPr>
            <a:xfrm>
              <a:off x="5465474" y="5548191"/>
              <a:ext cx="131482" cy="128791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13167201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2069" y="3620308"/>
            <a:ext cx="3264291" cy="202021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82156" y="3620306"/>
            <a:ext cx="3198457" cy="202021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362222" y="3478218"/>
            <a:ext cx="412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I.</a:t>
            </a:r>
            <a:endParaRPr lang="en-GB" sz="12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5125823" y="3478218"/>
            <a:ext cx="412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J.</a:t>
            </a:r>
            <a:endParaRPr lang="en-GB" sz="12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8007905" y="6581001"/>
            <a:ext cx="18803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l Figure 1</a:t>
            </a:r>
            <a:endParaRPr lang="en-GB" sz="1200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56385" y="761191"/>
            <a:ext cx="3198457" cy="202021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01862" y="748310"/>
            <a:ext cx="3198457" cy="202021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5004" y="748313"/>
            <a:ext cx="3198457" cy="202021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5262" y="559328"/>
            <a:ext cx="412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F.</a:t>
            </a:r>
            <a:endParaRPr lang="en-GB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448921" y="559327"/>
            <a:ext cx="412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G.</a:t>
            </a:r>
            <a:endParaRPr lang="en-GB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6702882" y="559326"/>
            <a:ext cx="412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H.</a:t>
            </a:r>
            <a:endParaRPr lang="en-GB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2197248" y="798489"/>
            <a:ext cx="7648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p=0.026</a:t>
            </a:r>
            <a:endParaRPr lang="en-GB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5514490" y="748313"/>
            <a:ext cx="7648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p=0.014</a:t>
            </a:r>
            <a:endParaRPr lang="en-GB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8811483" y="697825"/>
            <a:ext cx="7648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p=0.002</a:t>
            </a:r>
            <a:endParaRPr lang="en-GB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3575689" y="3755217"/>
            <a:ext cx="7648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p=0.231</a:t>
            </a:r>
            <a:endParaRPr lang="en-GB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7256837" y="3616717"/>
            <a:ext cx="7648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p=0.059</a:t>
            </a:r>
            <a:endParaRPr lang="en-GB" sz="1200" dirty="0"/>
          </a:p>
        </p:txBody>
      </p:sp>
      <p:grpSp>
        <p:nvGrpSpPr>
          <p:cNvPr id="18" name="Group 17"/>
          <p:cNvGrpSpPr/>
          <p:nvPr/>
        </p:nvGrpSpPr>
        <p:grpSpPr>
          <a:xfrm>
            <a:off x="2991854" y="3107387"/>
            <a:ext cx="4108804" cy="253595"/>
            <a:chOff x="3107765" y="5489980"/>
            <a:chExt cx="4108804" cy="253595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7"/>
            <a:srcRect l="72421" t="7546" b="85563"/>
            <a:stretch/>
          </p:blipFill>
          <p:spPr>
            <a:xfrm>
              <a:off x="3400424" y="5489980"/>
              <a:ext cx="1436609" cy="215495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7"/>
            <a:srcRect l="72453" t="14398" b="78421"/>
            <a:stretch/>
          </p:blipFill>
          <p:spPr>
            <a:xfrm>
              <a:off x="5781674" y="5519047"/>
              <a:ext cx="1434895" cy="224528"/>
            </a:xfrm>
            <a:prstGeom prst="rect">
              <a:avLst/>
            </a:prstGeom>
          </p:spPr>
        </p:pic>
        <p:sp>
          <p:nvSpPr>
            <p:cNvPr id="21" name="Oval 20"/>
            <p:cNvSpPr/>
            <p:nvPr/>
          </p:nvSpPr>
          <p:spPr>
            <a:xfrm>
              <a:off x="3107765" y="5545196"/>
              <a:ext cx="131482" cy="128791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Oval 21"/>
            <p:cNvSpPr/>
            <p:nvPr/>
          </p:nvSpPr>
          <p:spPr>
            <a:xfrm>
              <a:off x="5465474" y="5548191"/>
              <a:ext cx="131482" cy="128791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36327298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73</TotalTime>
  <Words>457</Words>
  <Application>Microsoft Office PowerPoint</Application>
  <PresentationFormat>A4 Paper (210x297 mm)</PresentationFormat>
  <Paragraphs>307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</dc:creator>
  <cp:lastModifiedBy>GOWRISHANKAR M</cp:lastModifiedBy>
  <cp:revision>140</cp:revision>
  <dcterms:created xsi:type="dcterms:W3CDTF">2015-05-20T08:17:11Z</dcterms:created>
  <dcterms:modified xsi:type="dcterms:W3CDTF">2015-11-23T22:24:31Z</dcterms:modified>
</cp:coreProperties>
</file>